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jpeg" ContentType="image/jpeg"/>
  <Override PartName="/ppt/media/image11.jpeg" ContentType="image/jpeg"/>
  <Override PartName="/ppt/media/image13.jpeg" ContentType="image/jpeg"/>
  <Override PartName="/ppt/media/image16.jpeg" ContentType="image/jpeg"/>
  <Override PartName="/ppt/media/image15.jpeg" ContentType="image/jpeg"/>
  <Override PartName="/ppt/media/image14.jpeg" ContentType="image/jpeg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media/image7.jpeg" ContentType="image/jpeg"/>
  <Override PartName="/ppt/media/image12.jpeg" ContentType="image/jpeg"/>
  <Override PartName="/ppt/media/image10.jpeg" ContentType="image/jpeg"/>
  <Override PartName="/ppt/media/image8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7772400" cy="100584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5DA01D-F4FF-4FC5-8688-AF03AA08BD1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4800" cy="16765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p>
            <a:pPr indent="0" algn="ctr">
              <a:buNone/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4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88800" y="2346120"/>
            <a:ext cx="6994800" cy="31665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88800" y="5814000"/>
            <a:ext cx="6994800" cy="31665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9F672A-E9E6-42EC-8067-0C88AE355A3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4800" cy="16765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p>
            <a:pPr indent="0" algn="ctr">
              <a:buNone/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4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88800" y="2346120"/>
            <a:ext cx="3413160" cy="31665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972960" y="2346120"/>
            <a:ext cx="3413160" cy="31665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88800" y="5814000"/>
            <a:ext cx="3413160" cy="31665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972960" y="5814000"/>
            <a:ext cx="3413160" cy="31665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4A16CF-A1D0-4FA4-8558-291C881AECA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4800" cy="16765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p>
            <a:pPr indent="0" algn="ctr">
              <a:buNone/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4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88800" y="2346120"/>
            <a:ext cx="2252160" cy="31665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754000" y="2346120"/>
            <a:ext cx="2252160" cy="31665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119200" y="2346120"/>
            <a:ext cx="2252160" cy="31665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88800" y="5814000"/>
            <a:ext cx="2252160" cy="31665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754000" y="5814000"/>
            <a:ext cx="2252160" cy="31665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119200" y="5814000"/>
            <a:ext cx="2252160" cy="31665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B1F398-E99A-4639-BFA8-2BE63C2CDE7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4800" cy="16765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p>
            <a:pPr indent="0" algn="ctr">
              <a:buNone/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4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88800" y="2346120"/>
            <a:ext cx="6994800" cy="6638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901"/>
              </a:spcBef>
              <a:buNone/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10ED49-1C59-46D8-BDD2-897E3B6F33F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4800" cy="16765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p>
            <a:pPr indent="0" algn="ctr">
              <a:buNone/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4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88800" y="2346120"/>
            <a:ext cx="6994800" cy="66387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A49E2C-D41A-44F5-AA7C-F2C50FA9817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4800" cy="16765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p>
            <a:pPr indent="0" algn="ctr">
              <a:buNone/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4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88800" y="2346120"/>
            <a:ext cx="3413160" cy="66387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972960" y="2346120"/>
            <a:ext cx="3413160" cy="66387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E4B6D0-D44A-4E4B-B473-1147F17F3C1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4800" cy="16765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p>
            <a:pPr indent="0" algn="ctr">
              <a:buNone/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4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55FA6D-0956-4A7E-96D9-7839BBF2ACD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88800" y="402840"/>
            <a:ext cx="6994800" cy="7772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901"/>
              </a:spcBef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EB0EA4-9FB5-427B-B9E1-C88E01ADDB1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4800" cy="16765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p>
            <a:pPr indent="0" algn="ctr">
              <a:buNone/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4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88800" y="2346120"/>
            <a:ext cx="3413160" cy="31665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972960" y="2346120"/>
            <a:ext cx="3413160" cy="66387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88800" y="5814000"/>
            <a:ext cx="3413160" cy="31665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2AF68D-78EE-4E60-BCBC-45DA352252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4800" cy="16765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p>
            <a:pPr indent="0" algn="ctr">
              <a:buNone/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4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88800" y="2346120"/>
            <a:ext cx="3413160" cy="66387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972960" y="2346120"/>
            <a:ext cx="3413160" cy="31665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972960" y="5814000"/>
            <a:ext cx="3413160" cy="31665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84C4D3-8A81-4737-A424-5074C58ECE5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4800" cy="16765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p>
            <a:pPr indent="0" algn="ctr">
              <a:buNone/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4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88800" y="2346120"/>
            <a:ext cx="3413160" cy="31665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972960" y="2346120"/>
            <a:ext cx="3413160" cy="31665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88800" y="5814000"/>
            <a:ext cx="6994800" cy="31665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16A81E-1C06-405A-8ADD-38ECE12F3F7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4800" cy="16765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p>
            <a:pPr indent="0" algn="ctr">
              <a:buNone/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49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88800" y="2346120"/>
            <a:ext cx="6994800" cy="66387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marL="380880" indent="-380880">
              <a:spcBef>
                <a:spcPts val="901"/>
              </a:spcBef>
              <a:buClr>
                <a:srgbClr val="000000"/>
              </a:buClr>
              <a:buFont typeface="Arial"/>
              <a:buChar char="•"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  <a:p>
            <a:pPr lvl="1" marL="826920" indent="-317160">
              <a:spcBef>
                <a:spcPts val="901"/>
              </a:spcBef>
              <a:buClr>
                <a:srgbClr val="000000"/>
              </a:buClr>
              <a:buFont typeface="Arial"/>
              <a:buChar char="–"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  <a:p>
            <a:pPr lvl="2" marL="1273320" indent="-254160">
              <a:spcBef>
                <a:spcPts val="901"/>
              </a:spcBef>
              <a:buClr>
                <a:srgbClr val="000000"/>
              </a:buClr>
              <a:buFont typeface="Arial"/>
              <a:buChar char="•"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  <a:p>
            <a:pPr lvl="3" marL="1782720" indent="-253800">
              <a:spcBef>
                <a:spcPts val="901"/>
              </a:spcBef>
              <a:buClr>
                <a:srgbClr val="000000"/>
              </a:buClr>
              <a:buFont typeface="Arial"/>
              <a:buChar char="–"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  <a:p>
            <a:pPr lvl="4" marL="2292480" indent="-254160">
              <a:spcBef>
                <a:spcPts val="901"/>
              </a:spcBef>
              <a:buClr>
                <a:srgbClr val="000000"/>
              </a:buClr>
              <a:buFont typeface="Arial"/>
              <a:buChar char="»"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  <a:p>
            <a:pPr lvl="5" marL="2292480" indent="-254160">
              <a:spcBef>
                <a:spcPts val="901"/>
              </a:spcBef>
              <a:buClr>
                <a:srgbClr val="000000"/>
              </a:buClr>
              <a:buFont typeface="Arial"/>
              <a:buChar char="»"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  <a:p>
            <a:pPr lvl="6" marL="2292480" indent="-254160">
              <a:spcBef>
                <a:spcPts val="901"/>
              </a:spcBef>
              <a:buClr>
                <a:srgbClr val="000000"/>
              </a:buClr>
              <a:buFont typeface="Arial"/>
              <a:buChar char="»"/>
              <a:tabLst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88800" y="9323280"/>
            <a:ext cx="1812960" cy="5349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  <a:defRPr b="0" lang="en-US" sz="13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13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655720" y="9323280"/>
            <a:ext cx="2460960" cy="5349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p>
            <a:pPr indent="0">
              <a:buNone/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570640" y="9323280"/>
            <a:ext cx="1812960" cy="5349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  <a:defRPr b="0" lang="en-US" sz="13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fld id="{D1188039-3641-40EB-B637-2B576BED3B41}" type="slidenum">
              <a:rPr b="0" lang="en-US" sz="13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9.jpeg"/><Relationship Id="rId2" Type="http://schemas.openxmlformats.org/officeDocument/2006/relationships/image" Target="../media/image10.jpeg"/><Relationship Id="rId3" Type="http://schemas.openxmlformats.org/officeDocument/2006/relationships/image" Target="../media/image11.jpeg"/><Relationship Id="rId4" Type="http://schemas.openxmlformats.org/officeDocument/2006/relationships/image" Target="../media/image12.jpeg"/><Relationship Id="rId5" Type="http://schemas.openxmlformats.org/officeDocument/2006/relationships/image" Target="../media/image13.jpeg"/><Relationship Id="rId6" Type="http://schemas.openxmlformats.org/officeDocument/2006/relationships/image" Target="../media/image14.jpeg"/><Relationship Id="rId7" Type="http://schemas.openxmlformats.org/officeDocument/2006/relationships/image" Target="../media/image15.jpeg"/><Relationship Id="rId8" Type="http://schemas.openxmlformats.org/officeDocument/2006/relationships/image" Target="../media/image16.jpe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388800" y="403200"/>
            <a:ext cx="6994800" cy="89208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Autofit/>
          </a:bodyPr>
          <a:p>
            <a:pPr indent="0">
              <a:buNone/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Supplemental Figure 1.  Results of statistical analysis of subsets of 60 Lemont and 30 TeQing seeds for 16 elements.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For each given sample size n= 3-20 (X-axis), 200 datasets were created by randomly subsampling from among the 60 Lemont and 30 TeQing individual kernels, which were then compared by t-test .  The fraction (Y-axis) of the 200 comparisons wherein the Lemont subsample was found significantly different from the TeQing subsample with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&lt; 0.05 plotted in black,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&lt; 0.01 in blue. The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value of the t-test comparing the full parent populations (60 Lemont kernels versus 30 TeQing) is below the element name.</a:t>
            </a:r>
            <a:br>
              <a:rPr sz="1000"/>
            </a:b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33" descr=""/>
          <p:cNvPicPr/>
          <p:nvPr/>
        </p:nvPicPr>
        <p:blipFill>
          <a:blip r:embed="rId1"/>
          <a:srcRect l="6923" t="9547" r="0" b="0"/>
          <a:stretch/>
        </p:blipFill>
        <p:spPr>
          <a:xfrm>
            <a:off x="3956040" y="6939000"/>
            <a:ext cx="2967120" cy="209556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35" descr=""/>
          <p:cNvPicPr/>
          <p:nvPr/>
        </p:nvPicPr>
        <p:blipFill>
          <a:blip r:embed="rId2"/>
          <a:srcRect l="0" t="9066" r="2868" b="0"/>
          <a:stretch/>
        </p:blipFill>
        <p:spPr>
          <a:xfrm>
            <a:off x="870120" y="6927840"/>
            <a:ext cx="3095280" cy="210672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37" descr=""/>
          <p:cNvPicPr/>
          <p:nvPr/>
        </p:nvPicPr>
        <p:blipFill>
          <a:blip r:embed="rId3"/>
          <a:srcRect l="0" t="8817" r="2575" b="11239"/>
          <a:stretch/>
        </p:blipFill>
        <p:spPr>
          <a:xfrm>
            <a:off x="870120" y="5060880"/>
            <a:ext cx="3105000" cy="185256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39" descr=""/>
          <p:cNvPicPr/>
          <p:nvPr/>
        </p:nvPicPr>
        <p:blipFill>
          <a:blip r:embed="rId4"/>
          <a:srcRect l="0" t="8041" r="2835" b="9655"/>
          <a:stretch/>
        </p:blipFill>
        <p:spPr>
          <a:xfrm>
            <a:off x="868320" y="1344600"/>
            <a:ext cx="3097080" cy="190836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40" descr=""/>
          <p:cNvPicPr/>
          <p:nvPr/>
        </p:nvPicPr>
        <p:blipFill>
          <a:blip r:embed="rId5"/>
          <a:srcRect l="0" t="9314" r="2959" b="11425"/>
          <a:stretch/>
        </p:blipFill>
        <p:spPr>
          <a:xfrm>
            <a:off x="863640" y="3222720"/>
            <a:ext cx="3092400" cy="183672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38" descr=""/>
          <p:cNvPicPr/>
          <p:nvPr/>
        </p:nvPicPr>
        <p:blipFill>
          <a:blip r:embed="rId6"/>
          <a:srcRect l="6618" t="7808" r="0" b="9888"/>
          <a:stretch/>
        </p:blipFill>
        <p:spPr>
          <a:xfrm>
            <a:off x="3940200" y="1344600"/>
            <a:ext cx="2976480" cy="1908360"/>
          </a:xfrm>
          <a:prstGeom prst="rect">
            <a:avLst/>
          </a:prstGeom>
          <a:ln w="0">
            <a:noFill/>
          </a:ln>
        </p:spPr>
      </p:pic>
      <p:sp>
        <p:nvSpPr>
          <p:cNvPr id="48" name="TextBox 42"/>
          <p:cNvSpPr/>
          <p:nvPr/>
        </p:nvSpPr>
        <p:spPr>
          <a:xfrm>
            <a:off x="1061640" y="1324080"/>
            <a:ext cx="686520" cy="56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P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3.43e-08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Picture 36" descr=""/>
          <p:cNvPicPr/>
          <p:nvPr/>
        </p:nvPicPr>
        <p:blipFill>
          <a:blip r:embed="rId7"/>
          <a:srcRect l="6595" t="9516" r="0" b="9857"/>
          <a:stretch/>
        </p:blipFill>
        <p:spPr>
          <a:xfrm>
            <a:off x="3940200" y="3222720"/>
            <a:ext cx="2976480" cy="186840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34" descr=""/>
          <p:cNvPicPr/>
          <p:nvPr/>
        </p:nvPicPr>
        <p:blipFill>
          <a:blip r:embed="rId8"/>
          <a:srcRect l="6527" t="9143" r="2394" b="11937"/>
          <a:stretch/>
        </p:blipFill>
        <p:spPr>
          <a:xfrm>
            <a:off x="3940200" y="5075280"/>
            <a:ext cx="2901960" cy="1828800"/>
          </a:xfrm>
          <a:prstGeom prst="rect">
            <a:avLst/>
          </a:prstGeom>
          <a:ln w="0">
            <a:noFill/>
          </a:ln>
        </p:spPr>
      </p:pic>
      <p:sp>
        <p:nvSpPr>
          <p:cNvPr id="51" name="TextBox 41"/>
          <p:cNvSpPr/>
          <p:nvPr/>
        </p:nvSpPr>
        <p:spPr>
          <a:xfrm>
            <a:off x="3944520" y="1344600"/>
            <a:ext cx="686520" cy="56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K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2.23e-0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43"/>
          <p:cNvSpPr/>
          <p:nvPr/>
        </p:nvSpPr>
        <p:spPr>
          <a:xfrm>
            <a:off x="3912120" y="3166920"/>
            <a:ext cx="775080" cy="56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Ca-43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2.35e-0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44"/>
          <p:cNvSpPr/>
          <p:nvPr/>
        </p:nvSpPr>
        <p:spPr>
          <a:xfrm>
            <a:off x="1048320" y="3174840"/>
            <a:ext cx="686520" cy="56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Mg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9.01e-0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45"/>
          <p:cNvSpPr/>
          <p:nvPr/>
        </p:nvSpPr>
        <p:spPr>
          <a:xfrm>
            <a:off x="3921480" y="5003640"/>
            <a:ext cx="686520" cy="56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A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2.72e-1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46"/>
          <p:cNvSpPr/>
          <p:nvPr/>
        </p:nvSpPr>
        <p:spPr>
          <a:xfrm>
            <a:off x="1054440" y="5018040"/>
            <a:ext cx="775080" cy="56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Ca-44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1.70e-0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47"/>
          <p:cNvSpPr/>
          <p:nvPr/>
        </p:nvSpPr>
        <p:spPr>
          <a:xfrm>
            <a:off x="3912840" y="6877080"/>
            <a:ext cx="686520" cy="56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Co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6.73e-0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48"/>
          <p:cNvSpPr/>
          <p:nvPr/>
        </p:nvSpPr>
        <p:spPr>
          <a:xfrm>
            <a:off x="1059120" y="6881760"/>
            <a:ext cx="686520" cy="56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C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2.00e-0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18"/>
          <p:cNvSpPr/>
          <p:nvPr/>
        </p:nvSpPr>
        <p:spPr>
          <a:xfrm rot="16200000">
            <a:off x="103680" y="2115360"/>
            <a:ext cx="1636920" cy="320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Frac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0.0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 0.2 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0.4   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0.6  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 0.8   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1.0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20"/>
          <p:cNvSpPr/>
          <p:nvPr/>
        </p:nvSpPr>
        <p:spPr>
          <a:xfrm rot="16200000">
            <a:off x="103680" y="3953520"/>
            <a:ext cx="1636920" cy="320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Frac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0.0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 0.2 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0.4   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0.6  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 0.8   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1.0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23"/>
          <p:cNvSpPr/>
          <p:nvPr/>
        </p:nvSpPr>
        <p:spPr>
          <a:xfrm rot="16200000">
            <a:off x="103680" y="5803920"/>
            <a:ext cx="1636920" cy="320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Frac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0.0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 0.2 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0.4   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0.6  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 0.8   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1.0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24"/>
          <p:cNvSpPr/>
          <p:nvPr/>
        </p:nvSpPr>
        <p:spPr>
          <a:xfrm rot="16200000">
            <a:off x="103680" y="7663680"/>
            <a:ext cx="1636920" cy="320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Frac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0.0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 0.2 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0.4   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0.6  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 0.8   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1.0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26"/>
          <p:cNvSpPr/>
          <p:nvPr/>
        </p:nvSpPr>
        <p:spPr>
          <a:xfrm>
            <a:off x="1543680" y="8771040"/>
            <a:ext cx="2287800" cy="426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5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                    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 10 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                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15   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                  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2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ample size (n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27"/>
          <p:cNvSpPr/>
          <p:nvPr/>
        </p:nvSpPr>
        <p:spPr>
          <a:xfrm>
            <a:off x="4416840" y="8771040"/>
            <a:ext cx="2287800" cy="426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5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                    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 10 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                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15   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                  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2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ample size (n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title"/>
          </p:nvPr>
        </p:nvSpPr>
        <p:spPr>
          <a:xfrm>
            <a:off x="388800" y="403200"/>
            <a:ext cx="6994800" cy="89208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Autofit/>
          </a:bodyPr>
          <a:p>
            <a:pPr indent="0">
              <a:buNone/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Supplemental Figure 1Continued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5" name="Picture 25" descr=""/>
          <p:cNvPicPr/>
          <p:nvPr/>
        </p:nvPicPr>
        <p:blipFill>
          <a:blip r:embed="rId1"/>
          <a:srcRect l="0" t="8025" r="2089" b="11115"/>
          <a:stretch/>
        </p:blipFill>
        <p:spPr>
          <a:xfrm>
            <a:off x="880920" y="1219320"/>
            <a:ext cx="3121200" cy="1874880"/>
          </a:xfrm>
          <a:prstGeom prst="rect">
            <a:avLst/>
          </a:prstGeom>
          <a:ln w="0">
            <a:noFill/>
          </a:ln>
        </p:spPr>
      </p:pic>
      <p:pic>
        <p:nvPicPr>
          <p:cNvPr id="66" name="Picture 28" descr=""/>
          <p:cNvPicPr/>
          <p:nvPr/>
        </p:nvPicPr>
        <p:blipFill>
          <a:blip r:embed="rId2"/>
          <a:srcRect l="0" t="8832" r="2168" b="11025"/>
          <a:stretch/>
        </p:blipFill>
        <p:spPr>
          <a:xfrm>
            <a:off x="880920" y="4950000"/>
            <a:ext cx="3117960" cy="1857240"/>
          </a:xfrm>
          <a:prstGeom prst="rect">
            <a:avLst/>
          </a:prstGeom>
          <a:ln w="0">
            <a:noFill/>
          </a:ln>
        </p:spPr>
      </p:pic>
      <p:pic>
        <p:nvPicPr>
          <p:cNvPr id="67" name="Picture 24" descr=""/>
          <p:cNvPicPr/>
          <p:nvPr/>
        </p:nvPicPr>
        <p:blipFill>
          <a:blip r:embed="rId3"/>
          <a:srcRect l="0" t="9174" r="3004" b="0"/>
          <a:stretch/>
        </p:blipFill>
        <p:spPr>
          <a:xfrm>
            <a:off x="880920" y="6800760"/>
            <a:ext cx="3090960" cy="2105280"/>
          </a:xfrm>
          <a:prstGeom prst="rect">
            <a:avLst/>
          </a:prstGeom>
          <a:ln w="0">
            <a:noFill/>
          </a:ln>
        </p:spPr>
      </p:pic>
      <p:pic>
        <p:nvPicPr>
          <p:cNvPr id="68" name="Picture 22" descr=""/>
          <p:cNvPicPr/>
          <p:nvPr/>
        </p:nvPicPr>
        <p:blipFill>
          <a:blip r:embed="rId4"/>
          <a:srcRect l="5816" t="6442" r="0" b="11316"/>
          <a:stretch/>
        </p:blipFill>
        <p:spPr>
          <a:xfrm>
            <a:off x="3952800" y="1181160"/>
            <a:ext cx="3002040" cy="1906560"/>
          </a:xfrm>
          <a:prstGeom prst="rect">
            <a:avLst/>
          </a:prstGeom>
          <a:ln w="0">
            <a:noFill/>
          </a:ln>
        </p:spPr>
      </p:pic>
      <p:sp>
        <p:nvSpPr>
          <p:cNvPr id="69" name="TextBox 31"/>
          <p:cNvSpPr/>
          <p:nvPr/>
        </p:nvSpPr>
        <p:spPr>
          <a:xfrm>
            <a:off x="3961800" y="1193760"/>
            <a:ext cx="686520" cy="56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F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3.52e-08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0" name="Content Placeholder 14" descr=""/>
          <p:cNvPicPr/>
          <p:nvPr/>
        </p:nvPicPr>
        <p:blipFill>
          <a:blip r:embed="rId5"/>
          <a:srcRect l="0" t="9585" r="2353" b="10495"/>
          <a:stretch/>
        </p:blipFill>
        <p:spPr>
          <a:xfrm>
            <a:off x="880920" y="3111480"/>
            <a:ext cx="3124440" cy="1866960"/>
          </a:xfrm>
          <a:prstGeom prst="rect">
            <a:avLst/>
          </a:prstGeom>
          <a:ln w="0">
            <a:noFill/>
          </a:ln>
        </p:spPr>
      </p:pic>
      <p:pic>
        <p:nvPicPr>
          <p:cNvPr id="71" name="Picture 12" descr=""/>
          <p:cNvPicPr/>
          <p:nvPr/>
        </p:nvPicPr>
        <p:blipFill>
          <a:blip r:embed="rId6"/>
          <a:srcRect l="6290" t="9174" r="0" b="11503"/>
          <a:stretch/>
        </p:blipFill>
        <p:spPr>
          <a:xfrm>
            <a:off x="3968640" y="3110040"/>
            <a:ext cx="2986200" cy="1838160"/>
          </a:xfrm>
          <a:prstGeom prst="rect">
            <a:avLst/>
          </a:prstGeom>
          <a:ln w="0">
            <a:noFill/>
          </a:ln>
        </p:spPr>
      </p:pic>
      <p:pic>
        <p:nvPicPr>
          <p:cNvPr id="72" name="Picture 14" descr=""/>
          <p:cNvPicPr/>
          <p:nvPr/>
        </p:nvPicPr>
        <p:blipFill>
          <a:blip r:embed="rId7"/>
          <a:srcRect l="6573" t="8832" r="0" b="11025"/>
          <a:stretch/>
        </p:blipFill>
        <p:spPr>
          <a:xfrm>
            <a:off x="3978360" y="4948200"/>
            <a:ext cx="2976480" cy="1857240"/>
          </a:xfrm>
          <a:prstGeom prst="rect">
            <a:avLst/>
          </a:prstGeom>
          <a:ln w="0">
            <a:noFill/>
          </a:ln>
        </p:spPr>
      </p:pic>
      <p:sp>
        <p:nvSpPr>
          <p:cNvPr id="73" name="TextBox 15"/>
          <p:cNvSpPr/>
          <p:nvPr/>
        </p:nvSpPr>
        <p:spPr>
          <a:xfrm>
            <a:off x="1105200" y="1222200"/>
            <a:ext cx="686520" cy="56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Cu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4.01e-1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Box 16"/>
          <p:cNvSpPr/>
          <p:nvPr/>
        </p:nvSpPr>
        <p:spPr>
          <a:xfrm>
            <a:off x="3956400" y="3137040"/>
            <a:ext cx="686520" cy="56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M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2.41e-17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Box 17"/>
          <p:cNvSpPr/>
          <p:nvPr/>
        </p:nvSpPr>
        <p:spPr>
          <a:xfrm>
            <a:off x="1101240" y="3144960"/>
            <a:ext cx="686520" cy="56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Li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2.69e-0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Box 18"/>
          <p:cNvSpPr/>
          <p:nvPr/>
        </p:nvSpPr>
        <p:spPr>
          <a:xfrm>
            <a:off x="3964320" y="4932360"/>
            <a:ext cx="686520" cy="56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N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2.36e-0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Box 19"/>
          <p:cNvSpPr/>
          <p:nvPr/>
        </p:nvSpPr>
        <p:spPr>
          <a:xfrm>
            <a:off x="1089360" y="4937040"/>
            <a:ext cx="686520" cy="56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Mo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2.14e-0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Box 21"/>
          <p:cNvSpPr/>
          <p:nvPr/>
        </p:nvSpPr>
        <p:spPr>
          <a:xfrm>
            <a:off x="1093320" y="6797520"/>
            <a:ext cx="686520" cy="56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Ni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6.73e-0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9" name="Picture 26" descr=""/>
          <p:cNvPicPr/>
          <p:nvPr/>
        </p:nvPicPr>
        <p:blipFill>
          <a:blip r:embed="rId8"/>
          <a:srcRect l="6448" t="9174" r="0" b="0"/>
          <a:stretch/>
        </p:blipFill>
        <p:spPr>
          <a:xfrm>
            <a:off x="3983040" y="6800760"/>
            <a:ext cx="2981160" cy="2105280"/>
          </a:xfrm>
          <a:prstGeom prst="rect">
            <a:avLst/>
          </a:prstGeom>
          <a:ln w="0">
            <a:noFill/>
          </a:ln>
        </p:spPr>
      </p:pic>
      <p:sp>
        <p:nvSpPr>
          <p:cNvPr id="80" name="TextBox 20"/>
          <p:cNvSpPr/>
          <p:nvPr/>
        </p:nvSpPr>
        <p:spPr>
          <a:xfrm>
            <a:off x="4534200" y="6916680"/>
            <a:ext cx="686520" cy="56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Z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7.25e-29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Box 29"/>
          <p:cNvSpPr/>
          <p:nvPr/>
        </p:nvSpPr>
        <p:spPr>
          <a:xfrm rot="16200000">
            <a:off x="103680" y="1996200"/>
            <a:ext cx="1636920" cy="320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Frac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0.0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 0.2 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0.4   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0.6  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 0.8   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1.0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Box 30"/>
          <p:cNvSpPr/>
          <p:nvPr/>
        </p:nvSpPr>
        <p:spPr>
          <a:xfrm rot="16200000">
            <a:off x="103680" y="3844080"/>
            <a:ext cx="1636920" cy="320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Frac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0.0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 0.2 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0.4   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0.6  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 0.8   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1.0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Box 32"/>
          <p:cNvSpPr/>
          <p:nvPr/>
        </p:nvSpPr>
        <p:spPr>
          <a:xfrm rot="16200000">
            <a:off x="103680" y="5694480"/>
            <a:ext cx="1636920" cy="320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Frac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0.0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 0.2 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0.4   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0.6  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 0.8   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1.0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Box 33"/>
          <p:cNvSpPr/>
          <p:nvPr/>
        </p:nvSpPr>
        <p:spPr>
          <a:xfrm rot="16200000">
            <a:off x="103680" y="7551000"/>
            <a:ext cx="1636920" cy="320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Frac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0.0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 0.2 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0.4   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0.6  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 0.8   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1.0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Box 34"/>
          <p:cNvSpPr/>
          <p:nvPr/>
        </p:nvSpPr>
        <p:spPr>
          <a:xfrm>
            <a:off x="1562760" y="8648640"/>
            <a:ext cx="2287800" cy="426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5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                    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 10 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                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15   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                  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2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ample size (n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Box 35"/>
          <p:cNvSpPr/>
          <p:nvPr/>
        </p:nvSpPr>
        <p:spPr>
          <a:xfrm>
            <a:off x="4443120" y="8648640"/>
            <a:ext cx="2287800" cy="426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5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                    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 10 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                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15     </a:t>
            </a:r>
            <a:r>
              <a:rPr b="0" lang="en-US" sz="900" spc="-1" strike="noStrike">
                <a:solidFill>
                  <a:srgbClr val="000000"/>
                </a:solidFill>
                <a:latin typeface="Arial Narrow"/>
                <a:ea typeface="Arial"/>
              </a:rPr>
              <a:t>                      </a:t>
            </a: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2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ample size (n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1017720"/>
                <a:tab algn="l" pos="2035080"/>
                <a:tab algn="l" pos="3052800"/>
                <a:tab algn="l" pos="4070520"/>
                <a:tab algn="l" pos="5087880"/>
                <a:tab algn="l" pos="6105600"/>
                <a:tab algn="l" pos="7122960"/>
                <a:tab algn="l" pos="8140680"/>
                <a:tab algn="l" pos="9158400"/>
                <a:tab algn="l" pos="1017576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 Narrow"/>
                <a:ea typeface="Arial"/>
              </a:rPr>
              <a:t>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9-04T04:39:48Z</dcterms:created>
  <dc:creator>spinson</dc:creator>
  <dc:description/>
  <dc:language>en-US</dc:language>
  <cp:lastModifiedBy>ShannonPison</cp:lastModifiedBy>
  <dcterms:modified xsi:type="dcterms:W3CDTF">2013-09-05T18:44:55Z</dcterms:modified>
  <cp:revision>13</cp:revision>
  <dc:subject/>
  <dc:title>Supplemental Figure 1.  Results of statistical analysis of subsets of 60 Lemont and 30 TeQing seeds for 16 elements. For each given sample size n= 3-20, 200 datasets were created by randomly subsampling from among the 60 Lemont and 30 TeQing individual kernels, which were then compared by t-test .  The fraction of the 200 comparisons wherein the Lemont subsample was found significantly different from the TeQing subsample with p &lt; 0.05 is plotted in black, p &lt; 0.01 is in blue. The p-value of the test comparing the full parent populations (60 Lemont kernels versus 30 TeQing) is listed in the title, following each  element name.</dc:title>
</cp:coreProperties>
</file>